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0" r:id="rId2"/>
    <p:sldId id="261" r:id="rId3"/>
    <p:sldId id="268" r:id="rId4"/>
    <p:sldId id="266" r:id="rId5"/>
    <p:sldId id="269" r:id="rId6"/>
  </p:sldIdLst>
  <p:sldSz cx="17068800" cy="9601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85" autoAdjust="0"/>
    <p:restoredTop sz="94660"/>
  </p:normalViewPr>
  <p:slideViewPr>
    <p:cSldViewPr snapToGrid="0">
      <p:cViewPr varScale="1">
        <p:scale>
          <a:sx n="54" d="100"/>
          <a:sy n="54" d="100"/>
        </p:scale>
        <p:origin x="104" y="3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C0364-9339-43C9-86EB-4CC054442722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CC6BF-57CC-419A-BFEB-A95A6429B2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11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的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1850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1801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0127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0582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33600" y="1571308"/>
            <a:ext cx="1280160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33600" y="5042853"/>
            <a:ext cx="128016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383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715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214860" y="511175"/>
            <a:ext cx="3680460" cy="813657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73480" y="511175"/>
            <a:ext cx="10828020" cy="813657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918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740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4590" y="2393634"/>
            <a:ext cx="1472184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4590" y="6425249"/>
            <a:ext cx="1472184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601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734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410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99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3" y="511176"/>
            <a:ext cx="14721840" cy="1855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5704" y="2353628"/>
            <a:ext cx="7220902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75704" y="3507105"/>
            <a:ext cx="7220902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641080" y="2353628"/>
            <a:ext cx="7256463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641080" y="3507105"/>
            <a:ext cx="7256463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94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68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456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256463" y="1382396"/>
            <a:ext cx="864108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086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256463" y="1382396"/>
            <a:ext cx="864108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275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73480" y="511176"/>
            <a:ext cx="1472184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3480" y="2555875"/>
            <a:ext cx="1472184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7348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54040" y="8898891"/>
            <a:ext cx="576072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05484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647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9D34A2E0-CD12-625A-B2EB-0B9FFC808364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FB4803F-92C1-9185-15D4-385A7BBAE798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32ED90C-573F-4BE7-319F-435D1F4399B1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D257A13-288F-9BCE-29F3-3787E792309A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6935C3F-0001-935A-5D86-A2BF4B37DB92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49656AF3-BE2F-C50C-A09F-749B1635E79D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D980CA4-E49D-DEA6-0C27-F53D72DD17F5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9 (56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8 (82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A27D032-D778-7385-B696-6B7AF7E810D7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5.0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.6 months (2.7-6.0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FD369FA-F86D-469F-0FFB-F6B977F0790F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6 (0.19-0.67)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13307D8-2DE0-9C39-AB40-39C80D988329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DF9459C-2AA3-00E7-D12F-381B4B772753}"/>
                </a:ext>
              </a:extLst>
            </p:cNvPr>
            <p:cNvSpPr txBox="1"/>
            <p:nvPr/>
          </p:nvSpPr>
          <p:spPr>
            <a:xfrm>
              <a:off x="5498764" y="1280277"/>
              <a:ext cx="2364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ab-Paclitaxel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2731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2A2BBBC0-3A37-0846-B902-1C22A2660A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955"/>
            <a:ext cx="17068800" cy="9593290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37D7E76E-E7A9-F4B7-8472-49684B0F997E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4E73FEF-AF11-FC55-A08D-C8F730A74468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349C4D8-23FB-F82E-D102-D2372BB74E33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B27D654-D087-023F-526D-1D429E8A0B11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6C97530-6E5E-976A-A764-D674538A43FC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79314794-9CED-C7C1-5787-DB95A0243665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9325A6E4-C8D8-0395-10AF-A4A66EF6D88F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4 (57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8 (84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41BFCE55-F585-FF9A-3B54-78469858684A}"/>
                </a:ext>
              </a:extLst>
            </p:cNvPr>
            <p:cNvSpPr txBox="1"/>
            <p:nvPr/>
          </p:nvSpPr>
          <p:spPr>
            <a:xfrm>
              <a:off x="9643373" y="1280277"/>
              <a:ext cx="226215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4.9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.6 months (4.0-5.9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85D8AD4C-A5D9-DCDB-283D-A56C8E2120AA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40 (0.23-0.69)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6CD9DD1-39AD-FEB4-A9FC-3C30276F55F6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A03F84C-9252-C4E6-CBB2-F7D6ABC3603F}"/>
                </a:ext>
              </a:extLst>
            </p:cNvPr>
            <p:cNvSpPr txBox="1"/>
            <p:nvPr/>
          </p:nvSpPr>
          <p:spPr>
            <a:xfrm>
              <a:off x="5498764" y="1280277"/>
              <a:ext cx="2364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ab-Paclitaxel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66217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0FFF43A-C96B-DA20-F85C-2DA56ECE49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955"/>
            <a:ext cx="17068800" cy="9593290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E9F50A4E-BDC6-08F0-0EB8-9193BF963BB1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AC9CE2DE-50F4-F252-DB61-C92C415999E6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24C00A9-CD12-6F2F-6D90-D2CE88F70F75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E818D25-3F80-2654-F8CC-E47439B95812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0932B045-4642-20BC-0EAF-40CA4DF033C2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9EB1FECF-3E45-E2A1-C807-61BA37206983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6B9CBE26-DAFB-BD28-5F5A-1BBF59E19CD4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9 (56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8 (82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7EC56346-C39D-410A-5F40-B72E919537A7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5.0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.6 months (2.7-6.0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2093D7C-0A0C-FCA4-E6ED-C2703CB0F566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6 (0.19-0.67)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647BEAA-3698-B36F-0A97-7A456C9DB9DB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C935BA8-AF9A-A2EA-FE05-75330D02267C}"/>
                </a:ext>
              </a:extLst>
            </p:cNvPr>
            <p:cNvSpPr txBox="1"/>
            <p:nvPr/>
          </p:nvSpPr>
          <p:spPr>
            <a:xfrm>
              <a:off x="5498764" y="1280277"/>
              <a:ext cx="2364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ab-Paclitaxel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24338F28-3A48-0A42-13BD-BD84912F2EFB}"/>
              </a:ext>
            </a:extLst>
          </p:cNvPr>
          <p:cNvSpPr txBox="1"/>
          <p:nvPr/>
        </p:nvSpPr>
        <p:spPr>
          <a:xfrm rot="10800000">
            <a:off x="0" y="900156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529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975D583-233B-E13B-7A23-CDD991AC43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955"/>
            <a:ext cx="17068800" cy="9593290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0FAE4BBD-3C61-2814-7BCE-B72FD5FBF335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B64F5E2-3AA5-1804-F4C7-F2FB82A8FA3B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D8BB09C-7300-2B15-339F-C67CD7406CCE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70DCAD5-0495-A3AC-BFCA-22481954FFD3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0AC45A4-497D-4B58-7390-C5E7CF10F962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162C8CCE-863D-B8FD-50EB-D953F80C94FA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74DA5FD-359D-9A4B-B5C0-59714CAFD8C9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4 (33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4 (75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79D7EF1-0819-D887-F18F-C068E21B272E}"/>
                </a:ext>
              </a:extLst>
            </p:cNvPr>
            <p:cNvSpPr txBox="1"/>
            <p:nvPr/>
          </p:nvSpPr>
          <p:spPr>
            <a:xfrm>
              <a:off x="9643373" y="1280277"/>
              <a:ext cx="240322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8.7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3 months (7.9-14.8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843A6AD-B332-E11A-27FF-2E1751B97BD1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40 (0.20-0.77)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D414F1E-396E-4F4F-7C37-FCD68049B8AA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6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1D71284-90FA-6009-68A6-6483F6843F15}"/>
                </a:ext>
              </a:extLst>
            </p:cNvPr>
            <p:cNvSpPr txBox="1"/>
            <p:nvPr/>
          </p:nvSpPr>
          <p:spPr>
            <a:xfrm>
              <a:off x="5498764" y="1280277"/>
              <a:ext cx="2364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ab-Paclitaxel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4238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A84EC40-41E9-0232-002B-569E6EA882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955"/>
            <a:ext cx="17068800" cy="9593290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5AC2E778-5D9E-2A0C-620E-E3546A874875}"/>
              </a:ext>
            </a:extLst>
          </p:cNvPr>
          <p:cNvGrpSpPr/>
          <p:nvPr/>
        </p:nvGrpSpPr>
        <p:grpSpPr>
          <a:xfrm>
            <a:off x="5664204" y="209271"/>
            <a:ext cx="9851303" cy="1240808"/>
            <a:chOff x="5498764" y="685801"/>
            <a:chExt cx="9851303" cy="124080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810C18C-0B0D-8B07-3DBC-BB19D1EBC4CA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3D1F8B7-A45E-0970-1E0A-FCBEDFF842B6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7615D5BA-B56D-B22E-7D95-58456F88D178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DD0E342D-5D61-400E-4C09-FD5E3DB60EE7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44F306F5-7FAF-ED30-0FB1-023FAA41B465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FD26BD4-859F-879B-246E-CEAC7765263C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 (29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4 (70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DE401F6-9FDD-ED40-FE4F-1C15B70A81CA}"/>
                </a:ext>
              </a:extLst>
            </p:cNvPr>
            <p:cNvSpPr txBox="1"/>
            <p:nvPr/>
          </p:nvSpPr>
          <p:spPr>
            <a:xfrm>
              <a:off x="9643373" y="1280277"/>
              <a:ext cx="251863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26.5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.9 months (8.1-15.9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0641BE5-4F13-8E81-4F5F-BFE638ED2BC9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7 (0.16-0.82)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68E9C06-C2FA-DCE9-018D-4EFC729E430F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15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3399180-E18B-6F52-5502-05399C2E336E}"/>
                </a:ext>
              </a:extLst>
            </p:cNvPr>
            <p:cNvSpPr txBox="1"/>
            <p:nvPr/>
          </p:nvSpPr>
          <p:spPr>
            <a:xfrm>
              <a:off x="5498764" y="1280277"/>
              <a:ext cx="23647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ab-Paclitaxel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1E2D2C30-478D-9041-2F8C-CC0D3500431B}"/>
              </a:ext>
            </a:extLst>
          </p:cNvPr>
          <p:cNvSpPr txBox="1"/>
          <p:nvPr/>
        </p:nvSpPr>
        <p:spPr>
          <a:xfrm rot="10800000">
            <a:off x="0" y="1489988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5912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2</TotalTime>
  <Words>225</Words>
  <Application>Microsoft Office PowerPoint</Application>
  <PresentationFormat>自定义</PresentationFormat>
  <Paragraphs>70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xi wang</dc:creator>
  <cp:lastModifiedBy>chenxi wang</cp:lastModifiedBy>
  <cp:revision>25</cp:revision>
  <dcterms:created xsi:type="dcterms:W3CDTF">2023-03-27T12:21:00Z</dcterms:created>
  <dcterms:modified xsi:type="dcterms:W3CDTF">2023-10-18T05:08:31Z</dcterms:modified>
</cp:coreProperties>
</file>